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7559675" cy="10691813"/>
  <p:notesSz cx="6794500" cy="9906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89398" autoAdjust="0"/>
  </p:normalViewPr>
  <p:slideViewPr>
    <p:cSldViewPr snapToGrid="0">
      <p:cViewPr varScale="1">
        <p:scale>
          <a:sx n="50" d="100"/>
          <a:sy n="50" d="100"/>
        </p:scale>
        <p:origin x="62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9AD68-69B6-4F5B-8F66-44505A5AED04}" type="datetimeFigureOut">
              <a:rPr lang="es-ES" smtClean="0"/>
              <a:t>01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81610-9D4C-4F21-B1B5-D6A29BB2479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2535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9AD68-69B6-4F5B-8F66-44505A5AED04}" type="datetimeFigureOut">
              <a:rPr lang="es-ES" smtClean="0"/>
              <a:t>01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81610-9D4C-4F21-B1B5-D6A29BB2479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499371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9AD68-69B6-4F5B-8F66-44505A5AED04}" type="datetimeFigureOut">
              <a:rPr lang="es-ES" smtClean="0"/>
              <a:t>01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81610-9D4C-4F21-B1B5-D6A29BB2479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666516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9AD68-69B6-4F5B-8F66-44505A5AED04}" type="datetimeFigureOut">
              <a:rPr lang="es-ES" smtClean="0"/>
              <a:t>01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81610-9D4C-4F21-B1B5-D6A29BB2479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598179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9AD68-69B6-4F5B-8F66-44505A5AED04}" type="datetimeFigureOut">
              <a:rPr lang="es-ES" smtClean="0"/>
              <a:t>01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81610-9D4C-4F21-B1B5-D6A29BB2479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00953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9AD68-69B6-4F5B-8F66-44505A5AED04}" type="datetimeFigureOut">
              <a:rPr lang="es-ES" smtClean="0"/>
              <a:t>01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81610-9D4C-4F21-B1B5-D6A29BB2479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659849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9AD68-69B6-4F5B-8F66-44505A5AED04}" type="datetimeFigureOut">
              <a:rPr lang="es-ES" smtClean="0"/>
              <a:t>01/04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81610-9D4C-4F21-B1B5-D6A29BB2479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636851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9AD68-69B6-4F5B-8F66-44505A5AED04}" type="datetimeFigureOut">
              <a:rPr lang="es-ES" smtClean="0"/>
              <a:t>01/04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81610-9D4C-4F21-B1B5-D6A29BB2479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42043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9AD68-69B6-4F5B-8F66-44505A5AED04}" type="datetimeFigureOut">
              <a:rPr lang="es-ES" smtClean="0"/>
              <a:t>01/04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81610-9D4C-4F21-B1B5-D6A29BB2479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2025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9AD68-69B6-4F5B-8F66-44505A5AED04}" type="datetimeFigureOut">
              <a:rPr lang="es-ES" smtClean="0"/>
              <a:t>01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81610-9D4C-4F21-B1B5-D6A29BB2479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31392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9AD68-69B6-4F5B-8F66-44505A5AED04}" type="datetimeFigureOut">
              <a:rPr lang="es-ES" smtClean="0"/>
              <a:t>01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81610-9D4C-4F21-B1B5-D6A29BB2479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80083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69AD68-69B6-4F5B-8F66-44505A5AED04}" type="datetimeFigureOut">
              <a:rPr lang="es-ES" smtClean="0"/>
              <a:t>01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E81610-9D4C-4F21-B1B5-D6A29BB2479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7813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381FFB2A-43E1-445C-BE64-A397EFBCF0C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213" y="1071657"/>
            <a:ext cx="2908285" cy="3308508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B0A1D1FB-0EBE-4372-AA9B-B757682EB6B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1232" y="995517"/>
            <a:ext cx="3554361" cy="3148591"/>
          </a:xfrm>
          <a:prstGeom prst="rect">
            <a:avLst/>
          </a:prstGeom>
        </p:spPr>
      </p:pic>
      <p:sp>
        <p:nvSpPr>
          <p:cNvPr id="8" name="CuadroTexto 7">
            <a:extLst>
              <a:ext uri="{FF2B5EF4-FFF2-40B4-BE49-F238E27FC236}">
                <a16:creationId xmlns:a16="http://schemas.microsoft.com/office/drawing/2014/main" id="{9EF3CACF-4FED-4D42-9A09-A59E9AB5BF2A}"/>
              </a:ext>
            </a:extLst>
          </p:cNvPr>
          <p:cNvSpPr txBox="1"/>
          <p:nvPr/>
        </p:nvSpPr>
        <p:spPr>
          <a:xfrm>
            <a:off x="410874" y="57070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CuadroTexto 7">
            <a:extLst>
              <a:ext uri="{FF2B5EF4-FFF2-40B4-BE49-F238E27FC236}">
                <a16:creationId xmlns:a16="http://schemas.microsoft.com/office/drawing/2014/main" id="{FC2AAF9B-7D84-41FE-AAC5-D424134C7EA6}"/>
              </a:ext>
            </a:extLst>
          </p:cNvPr>
          <p:cNvSpPr txBox="1"/>
          <p:nvPr/>
        </p:nvSpPr>
        <p:spPr>
          <a:xfrm>
            <a:off x="3425766" y="570706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0" name="Group 12">
            <a:extLst>
              <a:ext uri="{FF2B5EF4-FFF2-40B4-BE49-F238E27FC236}">
                <a16:creationId xmlns:a16="http://schemas.microsoft.com/office/drawing/2014/main" id="{1A606411-A7DA-495C-8142-E4426AB9864A}"/>
              </a:ext>
            </a:extLst>
          </p:cNvPr>
          <p:cNvGrpSpPr/>
          <p:nvPr/>
        </p:nvGrpSpPr>
        <p:grpSpPr>
          <a:xfrm>
            <a:off x="355477" y="1385713"/>
            <a:ext cx="482690" cy="1672217"/>
            <a:chOff x="2578196" y="3896455"/>
            <a:chExt cx="482690" cy="1672217"/>
          </a:xfrm>
        </p:grpSpPr>
        <p:sp>
          <p:nvSpPr>
            <p:cNvPr id="11" name="TextBox 15">
              <a:extLst>
                <a:ext uri="{FF2B5EF4-FFF2-40B4-BE49-F238E27FC236}">
                  <a16:creationId xmlns:a16="http://schemas.microsoft.com/office/drawing/2014/main" id="{1EA2D8DB-6773-42A4-8DE2-1B8572E896DB}"/>
                </a:ext>
              </a:extLst>
            </p:cNvPr>
            <p:cNvSpPr txBox="1"/>
            <p:nvPr/>
          </p:nvSpPr>
          <p:spPr>
            <a:xfrm>
              <a:off x="2578196" y="3896455"/>
              <a:ext cx="4635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WTn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31">
              <a:extLst>
                <a:ext uri="{FF2B5EF4-FFF2-40B4-BE49-F238E27FC236}">
                  <a16:creationId xmlns:a16="http://schemas.microsoft.com/office/drawing/2014/main" id="{1A0E48AE-59A4-42E2-863E-7450EC74CC5D}"/>
                </a:ext>
              </a:extLst>
            </p:cNvPr>
            <p:cNvSpPr txBox="1"/>
            <p:nvPr/>
          </p:nvSpPr>
          <p:spPr>
            <a:xfrm>
              <a:off x="2597298" y="5322451"/>
              <a:ext cx="4635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WTp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9167C22E-F91B-4C67-A76A-121C15ADDAA3}"/>
              </a:ext>
            </a:extLst>
          </p:cNvPr>
          <p:cNvGrpSpPr/>
          <p:nvPr/>
        </p:nvGrpSpPr>
        <p:grpSpPr>
          <a:xfrm>
            <a:off x="3421440" y="1327526"/>
            <a:ext cx="465125" cy="1757014"/>
            <a:chOff x="2587747" y="3811658"/>
            <a:chExt cx="465125" cy="1757014"/>
          </a:xfrm>
        </p:grpSpPr>
        <p:sp>
          <p:nvSpPr>
            <p:cNvPr id="14" name="TextBox 15">
              <a:extLst>
                <a:ext uri="{FF2B5EF4-FFF2-40B4-BE49-F238E27FC236}">
                  <a16:creationId xmlns:a16="http://schemas.microsoft.com/office/drawing/2014/main" id="{260BAB51-92F7-4DB4-A021-DA9F77BA6800}"/>
                </a:ext>
              </a:extLst>
            </p:cNvPr>
            <p:cNvSpPr txBox="1"/>
            <p:nvPr/>
          </p:nvSpPr>
          <p:spPr>
            <a:xfrm>
              <a:off x="2587747" y="3811658"/>
              <a:ext cx="4555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On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31">
              <a:extLst>
                <a:ext uri="{FF2B5EF4-FFF2-40B4-BE49-F238E27FC236}">
                  <a16:creationId xmlns:a16="http://schemas.microsoft.com/office/drawing/2014/main" id="{97854512-AC24-4577-B1DE-6C692119EBBE}"/>
                </a:ext>
              </a:extLst>
            </p:cNvPr>
            <p:cNvSpPr txBox="1"/>
            <p:nvPr/>
          </p:nvSpPr>
          <p:spPr>
            <a:xfrm>
              <a:off x="2597298" y="5322451"/>
              <a:ext cx="4555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Op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" name="CuadroTexto 15">
            <a:extLst>
              <a:ext uri="{FF2B5EF4-FFF2-40B4-BE49-F238E27FC236}">
                <a16:creationId xmlns:a16="http://schemas.microsoft.com/office/drawing/2014/main" id="{BD7E44B5-9D06-43EC-A3EA-DF4B01ABE9F6}"/>
              </a:ext>
            </a:extLst>
          </p:cNvPr>
          <p:cNvSpPr txBox="1"/>
          <p:nvPr/>
        </p:nvSpPr>
        <p:spPr>
          <a:xfrm>
            <a:off x="170091" y="156258"/>
            <a:ext cx="1742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 Fig. 1</a:t>
            </a:r>
          </a:p>
        </p:txBody>
      </p:sp>
      <p:sp>
        <p:nvSpPr>
          <p:cNvPr id="2" name="Rectángulo 1"/>
          <p:cNvSpPr/>
          <p:nvPr/>
        </p:nvSpPr>
        <p:spPr>
          <a:xfrm>
            <a:off x="355477" y="4885405"/>
            <a:ext cx="6790116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. 1.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omposition of host microbiome at genus level between healthy and chronic colitis groups. Differential representation of OTUs (p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j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&lt; 0.05) level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etween healthy and chronic colitis WT mice (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Tn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vs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Tp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and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tween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ealthy and chronic colitis MCJ-deficient mice (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On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vs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Op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Each point represents a single OTU colored by phylum, grouped by genus and point´s size reflect the mean abundance of the sequenced data.</a:t>
            </a:r>
            <a:endParaRPr lang="es-E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293779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22</TotalTime>
  <Words>92</Words>
  <Application>Microsoft Office PowerPoint</Application>
  <PresentationFormat>Personalizado</PresentationFormat>
  <Paragraphs>8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>UPV/EH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inize PEÑA</dc:creator>
  <cp:lastModifiedBy>LETICIA ABECIA</cp:lastModifiedBy>
  <cp:revision>168</cp:revision>
  <cp:lastPrinted>2021-01-14T13:21:15Z</cp:lastPrinted>
  <dcterms:created xsi:type="dcterms:W3CDTF">2020-10-21T08:47:37Z</dcterms:created>
  <dcterms:modified xsi:type="dcterms:W3CDTF">2022-04-01T13:29:22Z</dcterms:modified>
</cp:coreProperties>
</file>